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ECD926-128C-4C34-B66B-35E56A56070C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AA5DDF-FD6D-4492-A2E7-1460FB3DB4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9072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</a:t>
            </a:r>
            <a:r>
              <a:rPr lang="en-US" b="1" dirty="0">
                <a:solidFill>
                  <a:srgbClr val="C00000"/>
                </a:solidFill>
                <a:latin typeface="Arial" panose="020B0604020202020204" pitchFamily="34" charset="0"/>
              </a:rPr>
              <a:t> Table S1.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</a:rPr>
              <a:t> Details of antibodies used for </a:t>
            </a:r>
            <a:r>
              <a:rPr lang="en-US" dirty="0" err="1">
                <a:solidFill>
                  <a:srgbClr val="000000"/>
                </a:solidFill>
                <a:latin typeface="Arial" panose="020B0604020202020204" pitchFamily="34" charset="0"/>
              </a:rPr>
              <a:t>immunohistochemical</a:t>
            </a:r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</a:rPr>
              <a:t> staining of TP53, RB1 and PTEN, along with the antigen-retrieval protocol used by each of the three laboratories employed in this study in the CLIA-certified clinical laboratory at MD Anderson Cancer Center (MDACC)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0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3417902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894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591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796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600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033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549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6295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301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924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8853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000C1-1A3F-4447-B6F1-522F37FBAEFF}" type="datetimeFigureOut">
              <a:rPr lang="en-US" smtClean="0"/>
              <a:t>9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06DBDE-B33F-416B-A2A9-D094D92AF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659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66794A0-1E67-41EF-A511-D9A88051165C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77567" y="1409875"/>
          <a:ext cx="11833456" cy="3497788"/>
        </p:xfrm>
        <a:graphic>
          <a:graphicData uri="http://schemas.openxmlformats.org/drawingml/2006/table">
            <a:tbl>
              <a:tblPr firstRow="1" firstCol="1" bandRow="1"/>
              <a:tblGrid>
                <a:gridCol w="770864">
                  <a:extLst>
                    <a:ext uri="{9D8B030D-6E8A-4147-A177-3AD203B41FA5}">
                      <a16:colId xmlns:a16="http://schemas.microsoft.com/office/drawing/2014/main" val="3917330844"/>
                    </a:ext>
                  </a:extLst>
                </a:gridCol>
                <a:gridCol w="1028831">
                  <a:extLst>
                    <a:ext uri="{9D8B030D-6E8A-4147-A177-3AD203B41FA5}">
                      <a16:colId xmlns:a16="http://schemas.microsoft.com/office/drawing/2014/main" val="1893925461"/>
                    </a:ext>
                  </a:extLst>
                </a:gridCol>
                <a:gridCol w="810319">
                  <a:extLst>
                    <a:ext uri="{9D8B030D-6E8A-4147-A177-3AD203B41FA5}">
                      <a16:colId xmlns:a16="http://schemas.microsoft.com/office/drawing/2014/main" val="2209209844"/>
                    </a:ext>
                  </a:extLst>
                </a:gridCol>
                <a:gridCol w="783003">
                  <a:extLst>
                    <a:ext uri="{9D8B030D-6E8A-4147-A177-3AD203B41FA5}">
                      <a16:colId xmlns:a16="http://schemas.microsoft.com/office/drawing/2014/main" val="847718800"/>
                    </a:ext>
                  </a:extLst>
                </a:gridCol>
                <a:gridCol w="1192714">
                  <a:extLst>
                    <a:ext uri="{9D8B030D-6E8A-4147-A177-3AD203B41FA5}">
                      <a16:colId xmlns:a16="http://schemas.microsoft.com/office/drawing/2014/main" val="1227804706"/>
                    </a:ext>
                  </a:extLst>
                </a:gridCol>
                <a:gridCol w="1484065">
                  <a:extLst>
                    <a:ext uri="{9D8B030D-6E8A-4147-A177-3AD203B41FA5}">
                      <a16:colId xmlns:a16="http://schemas.microsoft.com/office/drawing/2014/main" val="3459400759"/>
                    </a:ext>
                  </a:extLst>
                </a:gridCol>
                <a:gridCol w="1429437">
                  <a:extLst>
                    <a:ext uri="{9D8B030D-6E8A-4147-A177-3AD203B41FA5}">
                      <a16:colId xmlns:a16="http://schemas.microsoft.com/office/drawing/2014/main" val="890329823"/>
                    </a:ext>
                  </a:extLst>
                </a:gridCol>
                <a:gridCol w="1499433">
                  <a:extLst>
                    <a:ext uri="{9D8B030D-6E8A-4147-A177-3AD203B41FA5}">
                      <a16:colId xmlns:a16="http://schemas.microsoft.com/office/drawing/2014/main" val="1889465069"/>
                    </a:ext>
                  </a:extLst>
                </a:gridCol>
                <a:gridCol w="1499433">
                  <a:extLst>
                    <a:ext uri="{9D8B030D-6E8A-4147-A177-3AD203B41FA5}">
                      <a16:colId xmlns:a16="http://schemas.microsoft.com/office/drawing/2014/main" val="1081611200"/>
                    </a:ext>
                  </a:extLst>
                </a:gridCol>
                <a:gridCol w="1335357">
                  <a:extLst>
                    <a:ext uri="{9D8B030D-6E8A-4147-A177-3AD203B41FA5}">
                      <a16:colId xmlns:a16="http://schemas.microsoft.com/office/drawing/2014/main" val="1298887427"/>
                    </a:ext>
                  </a:extLst>
                </a:gridCol>
              </a:tblGrid>
              <a:tr h="534385"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Biomarker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ompany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at #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Clone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ime used in MDACC Hospital IHC Lab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ntibody Type (Specificity)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Immunogen (Product Description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Incubation Conditions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Antigen Retrieval 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Detection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5115656"/>
                  </a:ext>
                </a:extLst>
              </a:tr>
              <a:tr h="825867"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P5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Leica Microsystems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PA0057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DO-7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no change per lab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Mouse Monoclonal (anti-human)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Recombinant human wild type p53 protei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1 (ready-to-use), 15 min incubation at room temperature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algn="ctr" fontAlgn="t"/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Tris-EDTA buffer, pH 9.0, 20 min at 100 </a:t>
                      </a:r>
                      <a:r>
                        <a:rPr lang="en-US" sz="11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°C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HRP-labeled polymer;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Chromogen Substrate: DAB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4155856"/>
                  </a:ext>
                </a:extLst>
              </a:tr>
              <a:tr h="712512"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RB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albiochem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OP66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LM95.1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3/11/2019 - 3/30/2021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Mouse Monoclonal (anti-human)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a 56 </a:t>
                      </a:r>
                      <a:r>
                        <a:rPr lang="en-US" sz="1100" dirty="0" err="1">
                          <a:effectLst/>
                        </a:rPr>
                        <a:t>kDa</a:t>
                      </a:r>
                      <a:r>
                        <a:rPr lang="en-US" sz="1100" dirty="0">
                          <a:effectLst/>
                        </a:rPr>
                        <a:t> C-terminal fragment (~last 509 amino acids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30 dilution, 15 min incubation at room temperature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algn="ctr" fontAlgn="t"/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Tris-EDTA buffer, pH 9.0, 20 min at 100 </a:t>
                      </a:r>
                      <a:r>
                        <a:rPr lang="en-US" sz="11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°C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HRP-labeled polymer; Chromogen Substrate: DAB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6451118"/>
                  </a:ext>
                </a:extLst>
              </a:tr>
              <a:tr h="712512"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RB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D Bioscienc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54136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algn="ctr"/>
                      <a:r>
                        <a:rPr lang="en-US" sz="1100" dirty="0"/>
                        <a:t>G3-245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3/04/2021 - 03/31/2026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Mouse Monoclonal (anti-human)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Human </a:t>
                      </a:r>
                      <a:r>
                        <a:rPr lang="en-US" sz="1100" dirty="0" err="1">
                          <a:effectLst/>
                        </a:rPr>
                        <a:t>Rb</a:t>
                      </a:r>
                      <a:r>
                        <a:rPr lang="en-US" sz="1100" dirty="0">
                          <a:effectLst/>
                        </a:rPr>
                        <a:t> aa. 332-344 (middle close to N-terminal part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200 dilution, 15 min incubation at room temperature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algn="ctr" fontAlgn="t"/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Tris-EDTA buffer, pH 9.0, 20 min at 100 </a:t>
                      </a:r>
                      <a:r>
                        <a:rPr lang="en-US" sz="11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°C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HRP-labeled polymer; Chromogen Substrate: DAB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4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8112557"/>
                  </a:ext>
                </a:extLst>
              </a:tr>
              <a:tr h="712512"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1" i="0" u="none" strike="noStrike" cap="none">
                          <a:solidFill>
                            <a:schemeClr val="lt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PTE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Agilent 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Dako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M3627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6H2.1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no change per lab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Mouse Monoclonal (anti-human)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-terminal of PTEN (~last 100 amino acids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1:100 dilution, 15 min incubation at room temperature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algn="ctr" fontAlgn="t"/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Tris-EDTA buffer, pH 9.0, 20 min at 100 </a:t>
                      </a:r>
                      <a:r>
                        <a:rPr lang="en-US" sz="11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°C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tc>
                  <a:txBody>
                    <a:bodyPr/>
                    <a:lstStyle>
                      <a:lvl1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1pPr>
                      <a:lvl2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2pPr>
                      <a:lvl3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3pPr>
                      <a:lvl4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4pPr>
                      <a:lvl5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5pPr>
                      <a:lvl6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6pPr>
                      <a:lvl7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7pPr>
                      <a:lvl8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8pPr>
                      <a:lvl9pPr marR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Font typeface="Arial"/>
                        <a:defRPr sz="1400" b="0" i="0" u="none" strike="noStrike" cap="none">
                          <a:solidFill>
                            <a:schemeClr val="dk1"/>
                          </a:solidFill>
                          <a:latin typeface="Calibri" panose="020F0502020204030204"/>
                          <a:sym typeface="Arial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</a:rPr>
                        <a:t>HRP-labeled polymer; Chromogen Substrate: DAB</a:t>
                      </a:r>
                    </a:p>
                  </a:txBody>
                  <a:tcPr marL="68580" marR="68580" marT="0" marB="0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5B9BD5">
                        <a:tint val="20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66594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78563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9</Words>
  <Application>Microsoft Office PowerPoint</Application>
  <PresentationFormat>Widescreen</PresentationFormat>
  <Paragraphs>5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VA Health 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scuse, Paul *HS</dc:creator>
  <cp:lastModifiedBy>Viscuse, Paul *HS</cp:lastModifiedBy>
  <cp:revision>1</cp:revision>
  <dcterms:created xsi:type="dcterms:W3CDTF">2023-09-07T19:38:36Z</dcterms:created>
  <dcterms:modified xsi:type="dcterms:W3CDTF">2023-09-07T19:38:45Z</dcterms:modified>
</cp:coreProperties>
</file>